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724"/>
  </p:normalViewPr>
  <p:slideViewPr>
    <p:cSldViewPr snapToGrid="0">
      <p:cViewPr>
        <p:scale>
          <a:sx n="55" d="100"/>
          <a:sy n="55" d="100"/>
        </p:scale>
        <p:origin x="2936" y="7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8269-8064-7C4B-AE9F-EBCEDEF195DA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A091-94B6-4D4C-8EF4-A2C250F4B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227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8269-8064-7C4B-AE9F-EBCEDEF195DA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A091-94B6-4D4C-8EF4-A2C250F4B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268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8269-8064-7C4B-AE9F-EBCEDEF195DA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A091-94B6-4D4C-8EF4-A2C250F4B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621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8269-8064-7C4B-AE9F-EBCEDEF195DA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A091-94B6-4D4C-8EF4-A2C250F4B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817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8269-8064-7C4B-AE9F-EBCEDEF195DA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A091-94B6-4D4C-8EF4-A2C250F4B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834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8269-8064-7C4B-AE9F-EBCEDEF195DA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A091-94B6-4D4C-8EF4-A2C250F4B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6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8269-8064-7C4B-AE9F-EBCEDEF195DA}" type="datetimeFigureOut">
              <a:rPr lang="en-US" smtClean="0"/>
              <a:t>2/18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A091-94B6-4D4C-8EF4-A2C250F4B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01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8269-8064-7C4B-AE9F-EBCEDEF195DA}" type="datetimeFigureOut">
              <a:rPr lang="en-US" smtClean="0"/>
              <a:t>2/18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A091-94B6-4D4C-8EF4-A2C250F4B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429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8269-8064-7C4B-AE9F-EBCEDEF195DA}" type="datetimeFigureOut">
              <a:rPr lang="en-US" smtClean="0"/>
              <a:t>2/18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A091-94B6-4D4C-8EF4-A2C250F4B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561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8269-8064-7C4B-AE9F-EBCEDEF195DA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A091-94B6-4D4C-8EF4-A2C250F4B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551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8269-8064-7C4B-AE9F-EBCEDEF195DA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5A091-94B6-4D4C-8EF4-A2C250F4B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838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6A88269-8064-7C4B-AE9F-EBCEDEF195DA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D5A091-94B6-4D4C-8EF4-A2C250F4B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787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96633D59-838C-A604-D63E-5968105E9C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503" y="725329"/>
            <a:ext cx="2438400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45720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5" name="Picture 1">
            <a:extLst>
              <a:ext uri="{FF2B5EF4-FFF2-40B4-BE49-F238E27FC236}">
                <a16:creationId xmlns:a16="http://schemas.microsoft.com/office/drawing/2014/main" id="{9D549367-B056-55EF-8B63-3796FD4855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4500" y="971550"/>
            <a:ext cx="5613400" cy="6946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8BBE56E6-597C-CCA4-0247-853DE0BE99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6553" y="8307539"/>
            <a:ext cx="5761347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. S1. CEBPA transcription factor binds the regulatory region of IDUA gene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utput from PROMO analysis for transcription factors binding to CEBPA (</a:t>
            </a: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. Confirmation of CEBPA binding to IDUA using publicly available data from UCSC (</a:t>
            </a: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. 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4840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05C1035A-A0AF-7F82-1DDC-0E8A646542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5750" y="575415"/>
            <a:ext cx="215265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2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2049" name="Picture 1">
            <a:extLst>
              <a:ext uri="{FF2B5EF4-FFF2-40B4-BE49-F238E27FC236}">
                <a16:creationId xmlns:a16="http://schemas.microsoft.com/office/drawing/2014/main" id="{E0146F62-8282-04E7-1916-A636B40620B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750" y="952500"/>
            <a:ext cx="4724400" cy="157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34EEC0D3-B4C1-0556-7A91-2C5CDB6680E4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285750" y="2904385"/>
            <a:ext cx="5657850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2. Generation and validation of </a:t>
            </a:r>
            <a:r>
              <a:rPr kumimoji="0" lang="en-US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manised</a:t>
            </a: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SG-MPS 1 mice.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G-MPS1 mice underwent irradiation followed by CD34+ human hematopoietic stem cell transplantation. Engraftment success was assessed at 12 weeks post-transplantation via flow cytometry of peripheral blood, with &gt;10% hCD45+/HLA+ cells considered successful. Animals below this threshold (red zone) were excluded from the study.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4299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16</Words>
  <Application>Microsoft Macintosh PowerPoint</Application>
  <PresentationFormat>A4 Paper (210x297 mm)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eebye, Vikash</dc:creator>
  <cp:lastModifiedBy>Reebye, Vikash</cp:lastModifiedBy>
  <cp:revision>2</cp:revision>
  <dcterms:created xsi:type="dcterms:W3CDTF">2026-02-18T13:21:26Z</dcterms:created>
  <dcterms:modified xsi:type="dcterms:W3CDTF">2026-02-18T13:26:04Z</dcterms:modified>
</cp:coreProperties>
</file>